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24406D-7252-48A2-8E61-5B47A0067A00}" v="20" dt="2023-03-22T11:25:13.2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0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863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6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5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4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36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44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21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1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902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9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8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59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5020345B-E63F-CB6D-40AB-FB62ABAC88F6}"/>
              </a:ext>
            </a:extLst>
          </p:cNvPr>
          <p:cNvSpPr txBox="1"/>
          <p:nvPr/>
        </p:nvSpPr>
        <p:spPr>
          <a:xfrm>
            <a:off x="150742" y="5297864"/>
            <a:ext cx="9516353" cy="1415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2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+mn-ea"/>
              <a:cs typeface="Times New Roman" panose="02020603050405020304" pitchFamily="18" charset="0"/>
            </a:endParaRPr>
          </a:p>
          <a:p>
            <a:endParaRPr lang="en-US" sz="1200" kern="100" dirty="0">
              <a:solidFill>
                <a:srgbClr val="000000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Supplemental Figure S7.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atmap of the transcripts encoding transcription factors that were changed in the black and border tissues relative to the orange regions.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maps of log2 transformed mean normalized expression (log2(mean(normalized counts))) of selected transcription factors representing WRKY (A), </a:t>
            </a:r>
            <a:r>
              <a:rPr lang="en-US" sz="12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HLH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, ERF (C), TCP (D),IB (E), and GATA (F) families in black (B), middle (M), and control (CT) samples. </a:t>
            </a:r>
            <a:endParaRPr lang="en-GB" sz="12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b="1" dirty="0"/>
              <a:t> </a:t>
            </a:r>
            <a:endParaRPr 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4532B7E-1D78-D1B6-3956-DF2479AB7581}"/>
              </a:ext>
            </a:extLst>
          </p:cNvPr>
          <p:cNvSpPr txBox="1"/>
          <p:nvPr/>
        </p:nvSpPr>
        <p:spPr>
          <a:xfrm>
            <a:off x="2894726" y="3420574"/>
            <a:ext cx="2535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100" dirty="0"/>
              <a:t>E</a:t>
            </a:r>
            <a:endParaRPr lang="en-US" sz="11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82139C-F81C-A5E3-9EAA-319E2D4330EC}"/>
              </a:ext>
            </a:extLst>
          </p:cNvPr>
          <p:cNvSpPr txBox="1"/>
          <p:nvPr/>
        </p:nvSpPr>
        <p:spPr>
          <a:xfrm>
            <a:off x="6108261" y="3420574"/>
            <a:ext cx="248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100" dirty="0"/>
              <a:t>F</a:t>
            </a:r>
            <a:endParaRPr lang="en-US" sz="11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24AFA52-ED96-4350-BF86-B0E5CDCAA459}"/>
              </a:ext>
            </a:extLst>
          </p:cNvPr>
          <p:cNvSpPr txBox="1"/>
          <p:nvPr/>
        </p:nvSpPr>
        <p:spPr>
          <a:xfrm rot="5400000">
            <a:off x="3513163" y="5062132"/>
            <a:ext cx="64475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D4BBCE5-375A-4141-AEE7-A3CDC128DA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827" y="303484"/>
            <a:ext cx="7792304" cy="286419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34E7163-FF69-4C2C-91A9-BC91D38CA7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0827" y="3167682"/>
            <a:ext cx="8886268" cy="229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962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</TotalTime>
  <Words>92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a Machaj</dc:creator>
  <cp:lastModifiedBy>Christine Foyer (Biosciences)</cp:lastModifiedBy>
  <cp:revision>8</cp:revision>
  <dcterms:created xsi:type="dcterms:W3CDTF">2023-03-20T09:37:55Z</dcterms:created>
  <dcterms:modified xsi:type="dcterms:W3CDTF">2023-09-08T07:37:27Z</dcterms:modified>
</cp:coreProperties>
</file>